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4" r:id="rId2"/>
  </p:sldIdLst>
  <p:sldSz cx="12192000" cy="6858000"/>
  <p:notesSz cx="9144000" cy="6858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A1A80"/>
    <a:srgbClr val="002776"/>
    <a:srgbClr val="8A2FAF"/>
    <a:srgbClr val="9232B8"/>
    <a:srgbClr val="8956CE"/>
    <a:srgbClr val="8F0DB7"/>
    <a:srgbClr val="EF5A07"/>
    <a:srgbClr val="8064A2"/>
    <a:srgbClr val="9567D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097" autoAdjust="0"/>
    <p:restoredTop sz="94807" autoAdjust="0"/>
  </p:normalViewPr>
  <p:slideViewPr>
    <p:cSldViewPr snapToGrid="0">
      <p:cViewPr varScale="1">
        <p:scale>
          <a:sx n="52" d="100"/>
          <a:sy n="52" d="100"/>
        </p:scale>
        <p:origin x="103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9358900-8257-4F49-AC5D-AAB806A41C89}" type="datetimeFigureOut">
              <a:rPr lang="ko-KR" altLang="en-US" smtClean="0"/>
              <a:t>2015-10-28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FABD729-096C-42B7-B29D-A5CEA16132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6416100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E92F0C8-A04A-48F2-A8BA-C373947BD9EA}" type="datetimeFigureOut">
              <a:rPr lang="ko-KR" altLang="en-US" smtClean="0"/>
              <a:t>2015-10-28</a:t>
            </a:fld>
            <a:endParaRPr lang="ko-KR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14600" y="857250"/>
            <a:ext cx="4114800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300412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8109859-5D4B-4AC6-8FD5-CDBE2DC0A49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307289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altLang="ko-KR" smtClean="0"/>
              <a:t>Click to edit Master subtitle style</a:t>
            </a:r>
            <a:endParaRPr lang="ko-KR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81850D-9AFC-4304-9CAD-C4E42309558D}" type="datetimeFigureOut">
              <a:rPr lang="ko-KR" altLang="en-US" smtClean="0"/>
              <a:t>2015-10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1A88D-297F-4A1F-9369-AD29A6EBE0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012261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81850D-9AFC-4304-9CAD-C4E42309558D}" type="datetimeFigureOut">
              <a:rPr lang="ko-KR" altLang="en-US" smtClean="0"/>
              <a:t>2015-10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1A88D-297F-4A1F-9369-AD29A6EBE0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563352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81850D-9AFC-4304-9CAD-C4E42309558D}" type="datetimeFigureOut">
              <a:rPr lang="ko-KR" altLang="en-US" smtClean="0"/>
              <a:t>2015-10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1A88D-297F-4A1F-9369-AD29A6EBE0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120231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81850D-9AFC-4304-9CAD-C4E42309558D}" type="datetimeFigureOut">
              <a:rPr lang="ko-KR" altLang="en-US" smtClean="0"/>
              <a:t>2015-10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1A88D-297F-4A1F-9369-AD29A6EBE0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437427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81850D-9AFC-4304-9CAD-C4E42309558D}" type="datetimeFigureOut">
              <a:rPr lang="ko-KR" altLang="en-US" smtClean="0"/>
              <a:t>2015-10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1A88D-297F-4A1F-9369-AD29A6EBE0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266350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81850D-9AFC-4304-9CAD-C4E42309558D}" type="datetimeFigureOut">
              <a:rPr lang="ko-KR" altLang="en-US" smtClean="0"/>
              <a:t>2015-10-2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1A88D-297F-4A1F-9369-AD29A6EBE0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779108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81850D-9AFC-4304-9CAD-C4E42309558D}" type="datetimeFigureOut">
              <a:rPr lang="ko-KR" altLang="en-US" smtClean="0"/>
              <a:t>2015-10-28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1A88D-297F-4A1F-9369-AD29A6EBE0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995960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81850D-9AFC-4304-9CAD-C4E42309558D}" type="datetimeFigureOut">
              <a:rPr lang="ko-KR" altLang="en-US" smtClean="0"/>
              <a:t>2015-10-28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1A88D-297F-4A1F-9369-AD29A6EBE0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083257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81850D-9AFC-4304-9CAD-C4E42309558D}" type="datetimeFigureOut">
              <a:rPr lang="ko-KR" altLang="en-US" smtClean="0"/>
              <a:t>2015-10-28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1A88D-297F-4A1F-9369-AD29A6EBE0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96772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81850D-9AFC-4304-9CAD-C4E42309558D}" type="datetimeFigureOut">
              <a:rPr lang="ko-KR" altLang="en-US" smtClean="0"/>
              <a:t>2015-10-2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1A88D-297F-4A1F-9369-AD29A6EBE0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461263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81850D-9AFC-4304-9CAD-C4E42309558D}" type="datetimeFigureOut">
              <a:rPr lang="ko-KR" altLang="en-US" smtClean="0"/>
              <a:t>2015-10-2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1A88D-297F-4A1F-9369-AD29A6EBE0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170744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81850D-9AFC-4304-9CAD-C4E42309558D}" type="datetimeFigureOut">
              <a:rPr lang="ko-KR" altLang="en-US" smtClean="0"/>
              <a:t>2015-10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C1A88D-297F-4A1F-9369-AD29A6EBE0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422774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TextBox 31"/>
          <p:cNvSpPr txBox="1"/>
          <p:nvPr/>
        </p:nvSpPr>
        <p:spPr>
          <a:xfrm>
            <a:off x="356765" y="377030"/>
            <a:ext cx="7938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 Fig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243309" y="3624549"/>
            <a:ext cx="1141253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CR 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plification for detecting the virulence genes of E. coli strain KBP1315. </a:t>
            </a:r>
            <a:endParaRPr lang="en-US" altLang="ko-KR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nes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M, 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zer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000 DNA Marker (Intron); and 1 to 6, fragments corresponding to 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lF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480 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ucD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680 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pC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470 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yuA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700 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irp2 (250 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and 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roN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630 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respectively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2" name="Group 11"/>
          <p:cNvGrpSpPr/>
          <p:nvPr/>
        </p:nvGrpSpPr>
        <p:grpSpPr>
          <a:xfrm>
            <a:off x="2920797" y="853019"/>
            <a:ext cx="5024253" cy="2286001"/>
            <a:chOff x="191841" y="1701271"/>
            <a:chExt cx="5024253" cy="2286001"/>
          </a:xfrm>
        </p:grpSpPr>
        <p:grpSp>
          <p:nvGrpSpPr>
            <p:cNvPr id="13" name="Group 12"/>
            <p:cNvGrpSpPr/>
            <p:nvPr/>
          </p:nvGrpSpPr>
          <p:grpSpPr>
            <a:xfrm>
              <a:off x="279871" y="1701271"/>
              <a:ext cx="4936223" cy="2286001"/>
              <a:chOff x="1118967" y="1841121"/>
              <a:chExt cx="4936223" cy="2286001"/>
            </a:xfrm>
          </p:grpSpPr>
          <p:pic>
            <p:nvPicPr>
              <p:cNvPr id="19" name="Picture 18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765" t="31911" r="21530" b="30604"/>
              <a:stretch/>
            </p:blipFill>
            <p:spPr>
              <a:xfrm>
                <a:off x="1118967" y="1841121"/>
                <a:ext cx="4936223" cy="2286001"/>
              </a:xfrm>
              <a:prstGeom prst="rect">
                <a:avLst/>
              </a:prstGeom>
            </p:spPr>
          </p:pic>
          <p:sp>
            <p:nvSpPr>
              <p:cNvPr id="20" name="TextBox 19"/>
              <p:cNvSpPr txBox="1"/>
              <p:nvPr/>
            </p:nvSpPr>
            <p:spPr>
              <a:xfrm>
                <a:off x="1947135" y="3700631"/>
                <a:ext cx="57099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600" dirty="0" err="1" smtClean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ylF</a:t>
                </a:r>
                <a:endParaRPr lang="ko-KR" altLang="en-US" sz="16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2521527" y="3700631"/>
                <a:ext cx="59343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600" dirty="0" err="1" smtClean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ucD</a:t>
                </a:r>
                <a:endParaRPr lang="ko-KR" altLang="en-US" sz="16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3085161" y="3700631"/>
                <a:ext cx="61747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600" dirty="0" err="1" smtClean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apC</a:t>
                </a:r>
                <a:endParaRPr lang="ko-KR" altLang="en-US" sz="16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3724101" y="3700631"/>
                <a:ext cx="60625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600" dirty="0" err="1" smtClean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yuA</a:t>
                </a:r>
                <a:endParaRPr lang="ko-KR" altLang="en-US" sz="16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4287735" y="3700631"/>
                <a:ext cx="52610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600" dirty="0" smtClean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rp2</a:t>
                </a:r>
                <a:endParaRPr lang="ko-KR" altLang="en-US" sz="16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4872885" y="3700631"/>
                <a:ext cx="559769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600" dirty="0" err="1" smtClean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roN</a:t>
                </a:r>
                <a:endParaRPr lang="ko-KR" altLang="en-US" sz="16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4" name="TextBox 13"/>
            <p:cNvSpPr txBox="1"/>
            <p:nvPr/>
          </p:nvSpPr>
          <p:spPr>
            <a:xfrm>
              <a:off x="191841" y="3071464"/>
              <a:ext cx="55496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0 </a:t>
              </a:r>
              <a:r>
                <a:rPr lang="en-US" altLang="ko-KR" sz="1050" dirty="0" err="1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p</a:t>
              </a:r>
              <a:endParaRPr lang="ko-KR" altLang="en-US" sz="105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08231" y="2834945"/>
              <a:ext cx="38664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0</a:t>
              </a:r>
              <a:endParaRPr lang="ko-KR" altLang="en-US" sz="105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98452" y="2668759"/>
              <a:ext cx="38664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50</a:t>
              </a:r>
              <a:endParaRPr lang="ko-KR" altLang="en-US" sz="105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98193" y="2489325"/>
              <a:ext cx="45397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0</a:t>
              </a:r>
              <a:endParaRPr lang="ko-KR" altLang="en-US" sz="105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91841" y="2318240"/>
              <a:ext cx="45397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00</a:t>
              </a:r>
              <a:endParaRPr lang="ko-KR" altLang="en-US" sz="105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8734031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523</TotalTime>
  <Words>80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NGSEOK LEE</dc:creator>
  <cp:lastModifiedBy>JS</cp:lastModifiedBy>
  <cp:revision>267</cp:revision>
  <cp:lastPrinted>2015-06-17T02:01:21Z</cp:lastPrinted>
  <dcterms:created xsi:type="dcterms:W3CDTF">2014-04-29T13:13:04Z</dcterms:created>
  <dcterms:modified xsi:type="dcterms:W3CDTF">2015-10-28T01:26:02Z</dcterms:modified>
</cp:coreProperties>
</file>